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Zanzibar\qpcr\cnv\cnv_experiment_sampl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DR!$T$12</c:f>
              <c:strCache>
                <c:ptCount val="1"/>
                <c:pt idx="0">
                  <c:v>UNGUJ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GDR!$AB$13:$AB$17</c:f>
                <c:numCache>
                  <c:formatCode>General</c:formatCode>
                  <c:ptCount val="5"/>
                  <c:pt idx="0">
                    <c:v>7.7177827630801388E-2</c:v>
                  </c:pt>
                  <c:pt idx="1">
                    <c:v>3.7480739059888905E-2</c:v>
                  </c:pt>
                  <c:pt idx="2">
                    <c:v>0.17143383416286651</c:v>
                  </c:pt>
                  <c:pt idx="3">
                    <c:v>0.10234589805409576</c:v>
                  </c:pt>
                  <c:pt idx="4">
                    <c:v>0.29251899911894264</c:v>
                  </c:pt>
                </c:numCache>
              </c:numRef>
            </c:plus>
            <c:minus>
              <c:numRef>
                <c:f>GDR!$AB$13:$AB$17</c:f>
                <c:numCache>
                  <c:formatCode>General</c:formatCode>
                  <c:ptCount val="5"/>
                  <c:pt idx="0">
                    <c:v>7.7177827630801388E-2</c:v>
                  </c:pt>
                  <c:pt idx="1">
                    <c:v>3.7480739059888905E-2</c:v>
                  </c:pt>
                  <c:pt idx="2">
                    <c:v>0.17143383416286651</c:v>
                  </c:pt>
                  <c:pt idx="3">
                    <c:v>0.10234589805409576</c:v>
                  </c:pt>
                  <c:pt idx="4">
                    <c:v>0.29251899911894264</c:v>
                  </c:pt>
                </c:numCache>
              </c:numRef>
            </c:minus>
          </c:errBars>
          <c:cat>
            <c:strRef>
              <c:f>GDR!$S$13:$S$17</c:f>
              <c:strCache>
                <c:ptCount val="5"/>
                <c:pt idx="0">
                  <c:v>CYPG16_utr</c:v>
                </c:pt>
                <c:pt idx="1">
                  <c:v>CYPG16_gq</c:v>
                </c:pt>
                <c:pt idx="2">
                  <c:v>CYP6Z2</c:v>
                </c:pt>
                <c:pt idx="3">
                  <c:v>CYP6Z3</c:v>
                </c:pt>
                <c:pt idx="4">
                  <c:v>Avg GDR GADPH</c:v>
                </c:pt>
              </c:strCache>
            </c:strRef>
          </c:cat>
          <c:val>
            <c:numRef>
              <c:f>GDR!$T$13:$T$16</c:f>
              <c:numCache>
                <c:formatCode>0.00</c:formatCode>
                <c:ptCount val="4"/>
                <c:pt idx="0">
                  <c:v>0.81147155446937691</c:v>
                </c:pt>
                <c:pt idx="1">
                  <c:v>0.64701150234243743</c:v>
                </c:pt>
                <c:pt idx="2" formatCode="General">
                  <c:v>1.0234184893837883</c:v>
                </c:pt>
                <c:pt idx="3" formatCode="General">
                  <c:v>0.352537677919324</c:v>
                </c:pt>
              </c:numCache>
            </c:numRef>
          </c:val>
        </c:ser>
        <c:ser>
          <c:idx val="1"/>
          <c:order val="1"/>
          <c:tx>
            <c:strRef>
              <c:f>GDR!$W$12</c:f>
              <c:strCache>
                <c:ptCount val="1"/>
                <c:pt idx="0">
                  <c:v>PEMBA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GDR!$AC$13:$AC$17</c:f>
                <c:numCache>
                  <c:formatCode>General</c:formatCode>
                  <c:ptCount val="5"/>
                  <c:pt idx="0">
                    <c:v>0.22392682638746778</c:v>
                  </c:pt>
                  <c:pt idx="1">
                    <c:v>3.8567034390369188E-2</c:v>
                  </c:pt>
                  <c:pt idx="2">
                    <c:v>0.46627746042616502</c:v>
                  </c:pt>
                  <c:pt idx="3">
                    <c:v>7.2403600152000855E-2</c:v>
                  </c:pt>
                  <c:pt idx="4">
                    <c:v>0.56934879514194869</c:v>
                  </c:pt>
                </c:numCache>
              </c:numRef>
            </c:plus>
            <c:minus>
              <c:numRef>
                <c:f>GDR!$AC$13:$AC$17</c:f>
                <c:numCache>
                  <c:formatCode>General</c:formatCode>
                  <c:ptCount val="5"/>
                  <c:pt idx="0">
                    <c:v>0.22392682638746778</c:v>
                  </c:pt>
                  <c:pt idx="1">
                    <c:v>3.8567034390369188E-2</c:v>
                  </c:pt>
                  <c:pt idx="2">
                    <c:v>0.46627746042616502</c:v>
                  </c:pt>
                  <c:pt idx="3">
                    <c:v>7.2403600152000855E-2</c:v>
                  </c:pt>
                  <c:pt idx="4">
                    <c:v>0.56934879514194869</c:v>
                  </c:pt>
                </c:numCache>
              </c:numRef>
            </c:minus>
          </c:errBars>
          <c:cat>
            <c:strRef>
              <c:f>GDR!$S$13:$S$17</c:f>
              <c:strCache>
                <c:ptCount val="5"/>
                <c:pt idx="0">
                  <c:v>CYPG16_utr</c:v>
                </c:pt>
                <c:pt idx="1">
                  <c:v>CYPG16_gq</c:v>
                </c:pt>
                <c:pt idx="2">
                  <c:v>CYP6Z2</c:v>
                </c:pt>
                <c:pt idx="3">
                  <c:v>CYP6Z3</c:v>
                </c:pt>
                <c:pt idx="4">
                  <c:v>Avg GDR GADPH</c:v>
                </c:pt>
              </c:strCache>
            </c:strRef>
          </c:cat>
          <c:val>
            <c:numRef>
              <c:f>GDR!$W$13:$W$16</c:f>
              <c:numCache>
                <c:formatCode>0.00</c:formatCode>
                <c:ptCount val="4"/>
                <c:pt idx="0">
                  <c:v>0.91016178659780189</c:v>
                </c:pt>
                <c:pt idx="1">
                  <c:v>0.65736863348334074</c:v>
                </c:pt>
                <c:pt idx="2" formatCode="General">
                  <c:v>1.0266086863320596</c:v>
                </c:pt>
                <c:pt idx="3" formatCode="General">
                  <c:v>0.285690058042234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515456"/>
        <c:axId val="40516992"/>
      </c:barChart>
      <c:catAx>
        <c:axId val="40515456"/>
        <c:scaling>
          <c:orientation val="minMax"/>
        </c:scaling>
        <c:delete val="0"/>
        <c:axPos val="b"/>
        <c:majorTickMark val="out"/>
        <c:minorTickMark val="none"/>
        <c:tickLblPos val="nextTo"/>
        <c:crossAx val="40516992"/>
        <c:crosses val="autoZero"/>
        <c:auto val="1"/>
        <c:lblAlgn val="ctr"/>
        <c:lblOffset val="100"/>
        <c:noMultiLvlLbl val="0"/>
      </c:catAx>
      <c:valAx>
        <c:axId val="4051699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Avg GDR (2-dCt)</a:t>
                </a:r>
              </a:p>
            </c:rich>
          </c:tx>
          <c:layout/>
          <c:overlay val="0"/>
        </c:title>
        <c:numFmt formatCode="0.00" sourceLinked="1"/>
        <c:majorTickMark val="out"/>
        <c:minorTickMark val="none"/>
        <c:tickLblPos val="nextTo"/>
        <c:crossAx val="40515456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8052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5720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5063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29183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17697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940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3496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7216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7631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07437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62373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99B85E-DBEF-47D8-95EF-417ED09E64F9}" type="datetimeFigureOut">
              <a:rPr lang="en-GB" smtClean="0"/>
              <a:t>11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6A82A9-934C-4AA4-A5D8-A8F462CF60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7769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/>
          <p:nvPr/>
        </p:nvGraphicFramePr>
        <p:xfrm>
          <a:off x="2303748" y="1412776"/>
          <a:ext cx="4045286" cy="2234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267744" y="3681028"/>
            <a:ext cx="4716524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/>
              <a:t>Figure S1. </a:t>
            </a:r>
            <a:r>
              <a:rPr lang="en-GB" sz="1400" dirty="0" smtClean="0"/>
              <a:t>Copy number variation of candidate p450s in </a:t>
            </a:r>
            <a:r>
              <a:rPr lang="en-GB" sz="1400" i="1" dirty="0" smtClean="0"/>
              <a:t>A. arabiensis </a:t>
            </a:r>
            <a:r>
              <a:rPr lang="en-GB" sz="1400" dirty="0" smtClean="0"/>
              <a:t>from Zanzibar.</a:t>
            </a:r>
          </a:p>
          <a:p>
            <a:endParaRPr lang="en-GB" sz="1400" dirty="0" smtClean="0"/>
          </a:p>
          <a:p>
            <a:r>
              <a:rPr lang="en-GB" sz="1400" dirty="0" smtClean="0"/>
              <a:t>The CNV of </a:t>
            </a:r>
            <a:r>
              <a:rPr lang="en-GB" sz="1400" i="1" dirty="0" smtClean="0"/>
              <a:t>CYP4G16</a:t>
            </a:r>
            <a:r>
              <a:rPr lang="en-GB" sz="1400" dirty="0" smtClean="0"/>
              <a:t>, </a:t>
            </a:r>
            <a:r>
              <a:rPr lang="en-GB" sz="1400" i="1" dirty="0" smtClean="0"/>
              <a:t>CYP6Z2</a:t>
            </a:r>
            <a:r>
              <a:rPr lang="en-GB" sz="1400" dirty="0" smtClean="0"/>
              <a:t> and </a:t>
            </a:r>
            <a:r>
              <a:rPr lang="en-GB" sz="1400" i="1" dirty="0" smtClean="0"/>
              <a:t>CYP6Z3</a:t>
            </a:r>
            <a:r>
              <a:rPr lang="en-GB" sz="1400" dirty="0" smtClean="0"/>
              <a:t> was analysed in individuals from </a:t>
            </a:r>
            <a:r>
              <a:rPr lang="en-GB" sz="1400" dirty="0" err="1" smtClean="0"/>
              <a:t>Unguja</a:t>
            </a:r>
            <a:r>
              <a:rPr lang="en-GB" sz="1400" dirty="0" smtClean="0"/>
              <a:t> and Pemba. Elongation factor as an endogenous control. Two separate primer pairs for </a:t>
            </a:r>
            <a:r>
              <a:rPr lang="en-GB" sz="1400" i="1" dirty="0" smtClean="0"/>
              <a:t>CYP4G16 </a:t>
            </a:r>
            <a:r>
              <a:rPr lang="en-GB" sz="1400" dirty="0" smtClean="0"/>
              <a:t>were tested; one in the 5’ UTR and one pair </a:t>
            </a:r>
            <a:r>
              <a:rPr lang="en-GB" sz="1400" dirty="0" err="1" smtClean="0"/>
              <a:t>exonic</a:t>
            </a:r>
            <a:r>
              <a:rPr lang="en-GB" sz="1400" dirty="0" smtClean="0"/>
              <a:t>. The gene dose ratio (GDR) with 95% CI was calculated as described previously (Ref) and showed no detectable difference between the two populations. 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387933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4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thamsted Resear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Jones</dc:creator>
  <cp:lastModifiedBy>Christopher Jones</cp:lastModifiedBy>
  <cp:revision>1</cp:revision>
  <dcterms:created xsi:type="dcterms:W3CDTF">2013-09-11T17:35:36Z</dcterms:created>
  <dcterms:modified xsi:type="dcterms:W3CDTF">2013-09-11T17:36:03Z</dcterms:modified>
</cp:coreProperties>
</file>